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FAFE26-C405-407A-B9E6-DB43A44F07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8A053E-A309-4D32-B2F0-AF7B4E2A7D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C581EA-CFAD-4579-8C0D-0F5BAF69122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C4E0E8-A669-4F7D-9813-7A82CB45AE1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277B42-B50F-43C2-89CC-40D62EEAD1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0D6D49-E5D9-47D2-AFC8-278433103E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888D6C-1DDB-4FA1-8E06-645A0C73DA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DA5991-BC4A-47A9-87CB-153C80E0C9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F3261B-B9DC-402E-AF2C-01EA4520AB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E6D6E1-722B-4037-AC1A-D57FD1AB40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647904-CED1-4D87-96CA-22E0E2724E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E9C2F-BE8C-44AF-A1B9-8D87CB07BD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C2AA33-DF90-4183-9304-173A085CA19C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3"/>
          <p:cNvSpPr/>
          <p:nvPr/>
        </p:nvSpPr>
        <p:spPr>
          <a:xfrm>
            <a:off x="11880" y="260280"/>
            <a:ext cx="779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2. Fasting blood glucose of normally fed and overfed zebrafish with and without tomato supplement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hart 1" descr=""/>
          <p:cNvPicPr/>
          <p:nvPr/>
        </p:nvPicPr>
        <p:blipFill>
          <a:blip r:embed="rId1"/>
          <a:stretch/>
        </p:blipFill>
        <p:spPr>
          <a:xfrm>
            <a:off x="901800" y="1195560"/>
            <a:ext cx="6468840" cy="3821040"/>
          </a:xfrm>
          <a:prstGeom prst="rect">
            <a:avLst/>
          </a:prstGeom>
          <a:ln w="0">
            <a:noFill/>
          </a:ln>
        </p:spPr>
      </p:pic>
      <p:sp>
        <p:nvSpPr>
          <p:cNvPr id="43" name="直線コネクタ 8"/>
          <p:cNvSpPr/>
          <p:nvPr/>
        </p:nvSpPr>
        <p:spPr>
          <a:xfrm>
            <a:off x="2556000" y="1989000"/>
            <a:ext cx="12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テキスト ボックス 9"/>
          <p:cNvSpPr/>
          <p:nvPr/>
        </p:nvSpPr>
        <p:spPr>
          <a:xfrm>
            <a:off x="3073320" y="168264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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直線コネクタ 10"/>
          <p:cNvSpPr/>
          <p:nvPr/>
        </p:nvSpPr>
        <p:spPr>
          <a:xfrm>
            <a:off x="3851280" y="1844640"/>
            <a:ext cx="2665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直線コネクタ 13"/>
          <p:cNvSpPr/>
          <p:nvPr/>
        </p:nvSpPr>
        <p:spPr>
          <a:xfrm>
            <a:off x="2556000" y="1989000"/>
            <a:ext cx="0" cy="719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テキスト ボックス 15"/>
          <p:cNvSpPr/>
          <p:nvPr/>
        </p:nvSpPr>
        <p:spPr>
          <a:xfrm>
            <a:off x="5019840" y="156852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テキスト ボックス 16"/>
          <p:cNvSpPr/>
          <p:nvPr/>
        </p:nvSpPr>
        <p:spPr>
          <a:xfrm>
            <a:off x="4281480" y="4869000"/>
            <a:ext cx="3396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&lt; 0.05, n = 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ach error bar indicates the standard deviati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22T03:49:10Z</dcterms:created>
  <dc:creator>Y. Shimada</dc:creator>
  <dc:description/>
  <dc:language>en-US</dc:language>
  <cp:lastModifiedBy>Y. Shimada</cp:lastModifiedBy>
  <dcterms:modified xsi:type="dcterms:W3CDTF">2011-12-02T03:22:30Z</dcterms:modified>
  <cp:revision>15</cp:revision>
  <dc:subject/>
  <dc:title>PowerPoint プレゼンテーション</dc:title>
</cp:coreProperties>
</file>